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slides/slide1.xml" ContentType="application/vnd.openxmlformats-officedocument.presentationml.slide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charts/colors2.xml" ContentType="application/vnd.ms-office.chartcolorstyle+xml"/>
  <Override PartName="/ppt/notesMasters/notesMaster1.xml" ContentType="application/vnd.openxmlformats-officedocument.presentationml.notesMaster+xml"/>
  <Override PartName="/ppt/charts/chart2.xml" ContentType="application/vnd.openxmlformats-officedocument.drawingml.chart+xml"/>
  <Override PartName="/ppt/charts/colors1.xml" ContentType="application/vnd.ms-office.chartcolorstyle+xml"/>
  <Override PartName="/ppt/theme/theme1.xml" ContentType="application/vnd.openxmlformats-officedocument.theme+xml"/>
  <Override PartName="/ppt/charts/chart1.xml" ContentType="application/vnd.openxmlformats-officedocument.drawingml.chart+xml"/>
  <Override PartName="/ppt/theme/theme2.xml" ContentType="application/vnd.openxmlformats-officedocument.theme+xml"/>
  <Override PartName="/ppt/charts/style1.xml" ContentType="application/vnd.ms-office.chartstyle+xml"/>
  <Override PartName="/ppt/charts/style2.xml" ContentType="application/vnd.ms-office.chartstyl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docProps/app.xml" ContentType="application/vnd.openxmlformats-officedocument.extended-properties+xml"/>
  <Override PartName="/docProps/core.xml" ContentType="application/vnd.openxmlformats-package.core-properties+xml"/>
  <Override PartName="/customXml/itemProps2.xml" ContentType="application/vnd.openxmlformats-officedocument.customXmlProperties+xml"/>
  <Override PartName="/customXml/itemProps1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095"/>
    <p:restoredTop sz="94613"/>
  </p:normalViewPr>
  <p:slideViewPr>
    <p:cSldViewPr snapToGrid="0">
      <p:cViewPr>
        <p:scale>
          <a:sx n="179" d="100"/>
          <a:sy n="179" d="100"/>
        </p:scale>
        <p:origin x="100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Charite.de\Centren\AG\AG-Endres\Daten\Gertz-Kronenberg\von%20Burcu\Paper_Ersoy_et_al\supp%20Figure4\OGD-VEH%20vs.%20CNTL-VEH%20gprofiler_results_1035999900994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Charite.de\Centren\AG\AG-Endres\Daten\Gertz-Kronenberg\von%20Burcu\Paper_Ersoy_et_al\supp%20Figure4\OGD-VEH%20vs.%20CNTL-VEH%20gprofiler_results_1035999900994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7477247347850365"/>
          <c:y val="2.6956972524624159E-2"/>
          <c:w val="0.50355899869718967"/>
          <c:h val="0.91375842405391394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rgbClr val="4732E6"/>
            </a:solidFill>
            <a:ln>
              <a:solidFill>
                <a:srgbClr val="002060"/>
              </a:solidFill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r>
                      <a:rPr lang="en-US"/>
                      <a:t>307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0-74DB-4AD5-B7D5-43334A1791EC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394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1-74DB-4AD5-B7D5-43334A1791EC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/>
                      <a:t>237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2-74DB-4AD5-B7D5-43334A1791EC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r>
                      <a:rPr lang="en-US"/>
                      <a:t>200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3-74DB-4AD5-B7D5-43334A1791EC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r>
                      <a:rPr lang="en-US"/>
                      <a:t>337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4-74DB-4AD5-B7D5-43334A1791EC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r>
                      <a:rPr lang="en-US"/>
                      <a:t>309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5-74DB-4AD5-B7D5-43334A1791EC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r>
                      <a:rPr lang="en-US"/>
                      <a:t>539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6-74DB-4AD5-B7D5-43334A1791EC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r>
                      <a:rPr lang="en-US"/>
                      <a:t>231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7-74DB-4AD5-B7D5-43334A1791EC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r>
                      <a:rPr lang="en-US"/>
                      <a:t>232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8-74DB-4AD5-B7D5-43334A1791EC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r>
                      <a:rPr lang="en-US"/>
                      <a:t>392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9-74DB-4AD5-B7D5-43334A1791EC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r>
                      <a:rPr lang="en-US"/>
                      <a:t>594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A-74DB-4AD5-B7D5-43334A1791EC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r>
                      <a:rPr lang="en-US"/>
                      <a:t>594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B-74DB-4AD5-B7D5-43334A1791EC}"/>
                </c:ext>
              </c:extLst>
            </c:dLbl>
            <c:dLbl>
              <c:idx val="12"/>
              <c:tx>
                <c:rich>
                  <a:bodyPr/>
                  <a:lstStyle/>
                  <a:p>
                    <a:r>
                      <a:rPr lang="en-US"/>
                      <a:t>391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C-74DB-4AD5-B7D5-43334A1791EC}"/>
                </c:ext>
              </c:extLst>
            </c:dLbl>
            <c:dLbl>
              <c:idx val="13"/>
              <c:tx>
                <c:rich>
                  <a:bodyPr/>
                  <a:lstStyle/>
                  <a:p>
                    <a:r>
                      <a:rPr lang="en-US"/>
                      <a:t>395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D-74DB-4AD5-B7D5-43334A1791EC}"/>
                </c:ext>
              </c:extLst>
            </c:dLbl>
            <c:dLbl>
              <c:idx val="14"/>
              <c:tx>
                <c:rich>
                  <a:bodyPr/>
                  <a:lstStyle/>
                  <a:p>
                    <a:r>
                      <a:rPr lang="en-US"/>
                      <a:t>368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E-74DB-4AD5-B7D5-43334A1791EC}"/>
                </c:ext>
              </c:extLst>
            </c:dLbl>
            <c:dLbl>
              <c:idx val="15"/>
              <c:tx>
                <c:rich>
                  <a:bodyPr/>
                  <a:lstStyle/>
                  <a:p>
                    <a:r>
                      <a:rPr lang="en-US"/>
                      <a:t>515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F-74DB-4AD5-B7D5-43334A1791EC}"/>
                </c:ext>
              </c:extLst>
            </c:dLbl>
            <c:dLbl>
              <c:idx val="16"/>
              <c:tx>
                <c:rich>
                  <a:bodyPr/>
                  <a:lstStyle/>
                  <a:p>
                    <a:r>
                      <a:rPr lang="en-US"/>
                      <a:t>346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0-74DB-4AD5-B7D5-43334A1791EC}"/>
                </c:ext>
              </c:extLst>
            </c:dLbl>
            <c:dLbl>
              <c:idx val="17"/>
              <c:tx>
                <c:rich>
                  <a:bodyPr/>
                  <a:lstStyle/>
                  <a:p>
                    <a:r>
                      <a:rPr lang="en-US"/>
                      <a:t>559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1-74DB-4AD5-B7D5-43334A1791EC}"/>
                </c:ext>
              </c:extLst>
            </c:dLbl>
            <c:dLbl>
              <c:idx val="18"/>
              <c:tx>
                <c:rich>
                  <a:bodyPr/>
                  <a:lstStyle/>
                  <a:p>
                    <a:r>
                      <a:rPr lang="en-US"/>
                      <a:t>638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2-74DB-4AD5-B7D5-43334A1791EC}"/>
                </c:ext>
              </c:extLst>
            </c:dLbl>
            <c:dLbl>
              <c:idx val="19"/>
              <c:tx>
                <c:rich>
                  <a:bodyPr/>
                  <a:lstStyle/>
                  <a:p>
                    <a:r>
                      <a:rPr lang="en-US"/>
                      <a:t>603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3-74DB-4AD5-B7D5-43334A1791E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6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DE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p-adj bonferroni'!$M$419:$M$438</c:f>
              <c:strCache>
                <c:ptCount val="20"/>
                <c:pt idx="0">
                  <c:v>     cell surface receptor signaling pathway</c:v>
                </c:pt>
                <c:pt idx="1">
                  <c:v>    regulation of biological quality</c:v>
                </c:pt>
                <c:pt idx="2">
                  <c:v>    positive regulation of multicellular organismal process</c:v>
                </c:pt>
                <c:pt idx="3">
                  <c:v>    cell-cell signaling</c:v>
                </c:pt>
                <c:pt idx="4">
                  <c:v>    cellular response to chemical stimulus</c:v>
                </c:pt>
                <c:pt idx="5">
                  <c:v>     intracellular signal transduction</c:v>
                </c:pt>
                <c:pt idx="6">
                  <c:v>    positive regulation of cellular process</c:v>
                </c:pt>
                <c:pt idx="7">
                  <c:v>     positive regulation of cell communication</c:v>
                </c:pt>
                <c:pt idx="8">
                  <c:v>    positive regulation of signaling</c:v>
                </c:pt>
                <c:pt idx="9">
                  <c:v>      animal organ development</c:v>
                </c:pt>
                <c:pt idx="10">
                  <c:v>   positive regulation of biological process</c:v>
                </c:pt>
                <c:pt idx="11">
                  <c:v>   localization</c:v>
                </c:pt>
                <c:pt idx="12">
                  <c:v>    regulation of cell communication</c:v>
                </c:pt>
                <c:pt idx="13">
                  <c:v>    regulation of signaling</c:v>
                </c:pt>
                <c:pt idx="14">
                  <c:v>    regulation of multicellular organismal process</c:v>
                </c:pt>
                <c:pt idx="15">
                  <c:v>     system development</c:v>
                </c:pt>
                <c:pt idx="16">
                  <c:v>    regulation of localization</c:v>
                </c:pt>
                <c:pt idx="17">
                  <c:v>    multicellular organism development</c:v>
                </c:pt>
                <c:pt idx="18">
                  <c:v>   developmental process</c:v>
                </c:pt>
                <c:pt idx="19">
                  <c:v>    anatomical structure development</c:v>
                </c:pt>
              </c:strCache>
            </c:strRef>
          </c:cat>
          <c:val>
            <c:numRef>
              <c:f>'p-adj bonferroni'!$D$419:$D$438</c:f>
              <c:numCache>
                <c:formatCode>General</c:formatCode>
                <c:ptCount val="20"/>
                <c:pt idx="0">
                  <c:v>19.497572880015568</c:v>
                </c:pt>
                <c:pt idx="1">
                  <c:v>19.576754126063193</c:v>
                </c:pt>
                <c:pt idx="2">
                  <c:v>19.696803942579511</c:v>
                </c:pt>
                <c:pt idx="3">
                  <c:v>20.407823242604135</c:v>
                </c:pt>
                <c:pt idx="4">
                  <c:v>20.578396073130168</c:v>
                </c:pt>
                <c:pt idx="5">
                  <c:v>20.585026652029182</c:v>
                </c:pt>
                <c:pt idx="6">
                  <c:v>21.324221658325914</c:v>
                </c:pt>
                <c:pt idx="7">
                  <c:v>21.394694953858892</c:v>
                </c:pt>
                <c:pt idx="8">
                  <c:v>21.548213564475709</c:v>
                </c:pt>
                <c:pt idx="9">
                  <c:v>22.141462802430361</c:v>
                </c:pt>
                <c:pt idx="10">
                  <c:v>23.958607314841775</c:v>
                </c:pt>
                <c:pt idx="11">
                  <c:v>23.978810700930062</c:v>
                </c:pt>
                <c:pt idx="12">
                  <c:v>24.835647144215564</c:v>
                </c:pt>
                <c:pt idx="13">
                  <c:v>25.463441557428471</c:v>
                </c:pt>
                <c:pt idx="14">
                  <c:v>26.12609840213554</c:v>
                </c:pt>
                <c:pt idx="15">
                  <c:v>28.129596094720974</c:v>
                </c:pt>
                <c:pt idx="16">
                  <c:v>28.486782399932061</c:v>
                </c:pt>
                <c:pt idx="17">
                  <c:v>28.815308569182402</c:v>
                </c:pt>
                <c:pt idx="18">
                  <c:v>30.406713932979542</c:v>
                </c:pt>
                <c:pt idx="19">
                  <c:v>31.0467236633326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74DB-4AD5-B7D5-43334A1791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468026624"/>
        <c:axId val="468026952"/>
      </c:barChart>
      <c:catAx>
        <c:axId val="46802662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DE"/>
          </a:p>
        </c:txPr>
        <c:crossAx val="468026952"/>
        <c:crosses val="autoZero"/>
        <c:auto val="1"/>
        <c:lblAlgn val="ctr"/>
        <c:lblOffset val="100"/>
        <c:noMultiLvlLbl val="0"/>
      </c:catAx>
      <c:valAx>
        <c:axId val="46802695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alpha val="25593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DE"/>
          </a:p>
        </c:txPr>
        <c:crossAx val="468026624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6476223711148335"/>
          <c:y val="6.7072204644642142E-2"/>
          <c:w val="0.50600223338916805"/>
          <c:h val="0.81985999817555921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rgbClr val="FFC000"/>
            </a:soli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r>
                      <a:rPr lang="en-US"/>
                      <a:t>108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0-BA46-4428-A125-A131B98EF178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94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1-BA46-4428-A125-A131B98EF178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/>
                      <a:t>102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2-BA46-4428-A125-A131B98EF178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r>
                      <a:rPr lang="en-US"/>
                      <a:t>132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3-BA46-4428-A125-A131B98EF178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r>
                      <a:rPr lang="en-US"/>
                      <a:t>73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4-BA46-4428-A125-A131B98EF178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r>
                      <a:rPr lang="en-US"/>
                      <a:t>33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5-BA46-4428-A125-A131B98EF178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r>
                      <a:rPr lang="en-US"/>
                      <a:t>66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6-BA46-4428-A125-A131B98EF178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r>
                      <a:rPr lang="en-US"/>
                      <a:t>116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7-BA46-4428-A125-A131B98EF178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r>
                      <a:rPr lang="en-US"/>
                      <a:t>111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8-BA46-4428-A125-A131B98EF178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r>
                      <a:rPr lang="en-US"/>
                      <a:t>129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9-BA46-4428-A125-A131B98EF178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r>
                      <a:rPr lang="en-US"/>
                      <a:t>143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A-BA46-4428-A125-A131B98EF178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r>
                      <a:rPr lang="en-US"/>
                      <a:t>52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B-BA46-4428-A125-A131B98EF178}"/>
                </c:ext>
              </c:extLst>
            </c:dLbl>
            <c:dLbl>
              <c:idx val="12"/>
              <c:tx>
                <c:rich>
                  <a:bodyPr/>
                  <a:lstStyle/>
                  <a:p>
                    <a:r>
                      <a:rPr lang="en-US"/>
                      <a:t>90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C-BA46-4428-A125-A131B98EF178}"/>
                </c:ext>
              </c:extLst>
            </c:dLbl>
            <c:dLbl>
              <c:idx val="13"/>
              <c:tx>
                <c:rich>
                  <a:bodyPr/>
                  <a:lstStyle/>
                  <a:p>
                    <a:r>
                      <a:rPr lang="en-US"/>
                      <a:t>72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D-BA46-4428-A125-A131B98EF178}"/>
                </c:ext>
              </c:extLst>
            </c:dLbl>
            <c:dLbl>
              <c:idx val="14"/>
              <c:tx>
                <c:rich>
                  <a:bodyPr/>
                  <a:lstStyle/>
                  <a:p>
                    <a:r>
                      <a:rPr lang="en-US"/>
                      <a:t>113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E-BA46-4428-A125-A131B98EF178}"/>
                </c:ext>
              </c:extLst>
            </c:dLbl>
            <c:dLbl>
              <c:idx val="15"/>
              <c:tx>
                <c:rich>
                  <a:bodyPr/>
                  <a:lstStyle/>
                  <a:p>
                    <a:r>
                      <a:rPr lang="en-US"/>
                      <a:t>118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F-BA46-4428-A125-A131B98EF178}"/>
                </c:ext>
              </c:extLst>
            </c:dLbl>
            <c:dLbl>
              <c:idx val="16"/>
              <c:tx>
                <c:rich>
                  <a:bodyPr/>
                  <a:lstStyle/>
                  <a:p>
                    <a:r>
                      <a:rPr lang="en-US"/>
                      <a:t>106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0-BA46-4428-A125-A131B98EF178}"/>
                </c:ext>
              </c:extLst>
            </c:dLbl>
            <c:dLbl>
              <c:idx val="17"/>
              <c:tx>
                <c:rich>
                  <a:bodyPr/>
                  <a:lstStyle/>
                  <a:p>
                    <a:r>
                      <a:rPr lang="en-US"/>
                      <a:t>164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1-BA46-4428-A125-A131B98EF178}"/>
                </c:ext>
              </c:extLst>
            </c:dLbl>
            <c:dLbl>
              <c:idx val="18"/>
              <c:tx>
                <c:rich>
                  <a:bodyPr/>
                  <a:lstStyle/>
                  <a:p>
                    <a:r>
                      <a:rPr lang="en-US"/>
                      <a:t>183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2-BA46-4428-A125-A131B98EF178}"/>
                </c:ext>
              </c:extLst>
            </c:dLbl>
            <c:dLbl>
              <c:idx val="19"/>
              <c:tx>
                <c:rich>
                  <a:bodyPr/>
                  <a:lstStyle/>
                  <a:p>
                    <a:r>
                      <a:rPr lang="en-US"/>
                      <a:t>195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3-BA46-4428-A125-A131B98EF17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6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DE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[1]p-adj bonferroni'!$M$83:$M$102</c:f>
              <c:strCache>
                <c:ptCount val="20"/>
                <c:pt idx="0">
                  <c:v>   regulation of cell communication</c:v>
                </c:pt>
                <c:pt idx="1">
                  <c:v>   regulation of localization</c:v>
                </c:pt>
                <c:pt idx="2">
                  <c:v>   regulation of multicellular organismal process</c:v>
                </c:pt>
                <c:pt idx="3">
                  <c:v>    cellular developmental process</c:v>
                </c:pt>
                <c:pt idx="4">
                  <c:v>     tissue development</c:v>
                </c:pt>
                <c:pt idx="5">
                  <c:v>    response to wounding</c:v>
                </c:pt>
                <c:pt idx="6">
                  <c:v>   response to endogenous stimulus</c:v>
                </c:pt>
                <c:pt idx="7">
                  <c:v>   regulation of biological quality</c:v>
                </c:pt>
                <c:pt idx="8">
                  <c:v>   regulation of signaling</c:v>
                </c:pt>
                <c:pt idx="9">
                  <c:v>     cell differentiation</c:v>
                </c:pt>
                <c:pt idx="10">
                  <c:v>     system development</c:v>
                </c:pt>
                <c:pt idx="11">
                  <c:v>    cellular response to oxygen-containing compound</c:v>
                </c:pt>
                <c:pt idx="12">
                  <c:v>    cellular response to organic substance</c:v>
                </c:pt>
                <c:pt idx="13">
                  <c:v>   response to oxygen-containing compound</c:v>
                </c:pt>
                <c:pt idx="14">
                  <c:v>   response to organic substance</c:v>
                </c:pt>
                <c:pt idx="15">
                  <c:v>      animal organ development</c:v>
                </c:pt>
                <c:pt idx="16">
                  <c:v>   cellular response to chemical stimulus</c:v>
                </c:pt>
                <c:pt idx="17">
                  <c:v>    multicellular organism development</c:v>
                </c:pt>
                <c:pt idx="18">
                  <c:v>    anatomical structure development</c:v>
                </c:pt>
                <c:pt idx="19">
                  <c:v>   developmental process</c:v>
                </c:pt>
              </c:strCache>
            </c:strRef>
          </c:cat>
          <c:val>
            <c:numRef>
              <c:f>'[1]p-adj bonferroni'!$D$83:$D$102</c:f>
              <c:numCache>
                <c:formatCode>General</c:formatCode>
                <c:ptCount val="20"/>
                <c:pt idx="0">
                  <c:v>4.5044556624535517</c:v>
                </c:pt>
                <c:pt idx="1">
                  <c:v>4.9030899869919438</c:v>
                </c:pt>
                <c:pt idx="2">
                  <c:v>4.9430951486635273</c:v>
                </c:pt>
                <c:pt idx="3">
                  <c:v>5.0181813928293364</c:v>
                </c:pt>
                <c:pt idx="4">
                  <c:v>5.0783135245163979</c:v>
                </c:pt>
                <c:pt idx="5">
                  <c:v>5.1999706407558657</c:v>
                </c:pt>
                <c:pt idx="6">
                  <c:v>5.2076083105017466</c:v>
                </c:pt>
                <c:pt idx="7">
                  <c:v>5.2291479883578562</c:v>
                </c:pt>
                <c:pt idx="8">
                  <c:v>5.2668027348934308</c:v>
                </c:pt>
                <c:pt idx="9">
                  <c:v>5.405607449624573</c:v>
                </c:pt>
                <c:pt idx="10">
                  <c:v>5.6497519816658368</c:v>
                </c:pt>
                <c:pt idx="11">
                  <c:v>5.6536470255493612</c:v>
                </c:pt>
                <c:pt idx="12">
                  <c:v>6.6073030467403342</c:v>
                </c:pt>
                <c:pt idx="13">
                  <c:v>6.7520267336381936</c:v>
                </c:pt>
                <c:pt idx="14">
                  <c:v>6.795880017344075</c:v>
                </c:pt>
                <c:pt idx="15">
                  <c:v>6.8761483590329142</c:v>
                </c:pt>
                <c:pt idx="16">
                  <c:v>7.7144426909922261</c:v>
                </c:pt>
                <c:pt idx="17">
                  <c:v>8.6073030467403342</c:v>
                </c:pt>
                <c:pt idx="18">
                  <c:v>11.630784142589857</c:v>
                </c:pt>
                <c:pt idx="19">
                  <c:v>12.1931419704811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BA46-4428-A125-A131B98EF1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414431376"/>
        <c:axId val="414431048"/>
      </c:barChart>
      <c:catAx>
        <c:axId val="41443137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DE"/>
          </a:p>
        </c:txPr>
        <c:crossAx val="414431048"/>
        <c:crosses val="autoZero"/>
        <c:auto val="1"/>
        <c:lblAlgn val="ctr"/>
        <c:lblOffset val="100"/>
        <c:noMultiLvlLbl val="0"/>
      </c:catAx>
      <c:valAx>
        <c:axId val="41443104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alpha val="26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DE"/>
          </a:p>
        </c:txPr>
        <c:crossAx val="414431376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64B203-9D49-014F-B44C-004B43F1B86D}" type="datetimeFigureOut">
              <a:rPr lang="en-DE" smtClean="0"/>
              <a:t>11.10.22</a:t>
            </a:fld>
            <a:endParaRPr lang="en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1FCB18-F31C-4546-8BFA-73FC591CB01B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454529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1FCB18-F31C-4546-8BFA-73FC591CB01B}" type="slidenum">
              <a:rPr lang="en-DE" smtClean="0"/>
              <a:t>1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0182964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n-US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6E73B-ED6C-4D8F-A27B-FDA5101F9EE2}" type="datetimeFigureOut">
              <a:rPr lang="de-DE" smtClean="0"/>
              <a:t>11.10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46B94-32AA-49AA-A716-890A97C63C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584165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6E73B-ED6C-4D8F-A27B-FDA5101F9EE2}" type="datetimeFigureOut">
              <a:rPr lang="de-DE" smtClean="0"/>
              <a:t>11.10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46B94-32AA-49AA-A716-890A97C63C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8446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6E73B-ED6C-4D8F-A27B-FDA5101F9EE2}" type="datetimeFigureOut">
              <a:rPr lang="de-DE" smtClean="0"/>
              <a:t>11.10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46B94-32AA-49AA-A716-890A97C63C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79325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6E73B-ED6C-4D8F-A27B-FDA5101F9EE2}" type="datetimeFigureOut">
              <a:rPr lang="de-DE" smtClean="0"/>
              <a:t>11.10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46B94-32AA-49AA-A716-890A97C63C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86726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6E73B-ED6C-4D8F-A27B-FDA5101F9EE2}" type="datetimeFigureOut">
              <a:rPr lang="de-DE" smtClean="0"/>
              <a:t>11.10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46B94-32AA-49AA-A716-890A97C63C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0332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6E73B-ED6C-4D8F-A27B-FDA5101F9EE2}" type="datetimeFigureOut">
              <a:rPr lang="de-DE" smtClean="0"/>
              <a:t>11.10.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46B94-32AA-49AA-A716-890A97C63C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94339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6E73B-ED6C-4D8F-A27B-FDA5101F9EE2}" type="datetimeFigureOut">
              <a:rPr lang="de-DE" smtClean="0"/>
              <a:t>11.10.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46B94-32AA-49AA-A716-890A97C63C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35665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6E73B-ED6C-4D8F-A27B-FDA5101F9EE2}" type="datetimeFigureOut">
              <a:rPr lang="de-DE" smtClean="0"/>
              <a:t>11.10.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46B94-32AA-49AA-A716-890A97C63C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70990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6E73B-ED6C-4D8F-A27B-FDA5101F9EE2}" type="datetimeFigureOut">
              <a:rPr lang="de-DE" smtClean="0"/>
              <a:t>11.10.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46B94-32AA-49AA-A716-890A97C63C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7728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6E73B-ED6C-4D8F-A27B-FDA5101F9EE2}" type="datetimeFigureOut">
              <a:rPr lang="de-DE" smtClean="0"/>
              <a:t>11.10.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46B94-32AA-49AA-A716-890A97C63C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36166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6E73B-ED6C-4D8F-A27B-FDA5101F9EE2}" type="datetimeFigureOut">
              <a:rPr lang="de-DE" smtClean="0"/>
              <a:t>11.10.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46B94-32AA-49AA-A716-890A97C63C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1146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86E73B-ED6C-4D8F-A27B-FDA5101F9EE2}" type="datetimeFigureOut">
              <a:rPr lang="de-DE" smtClean="0"/>
              <a:t>11.10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F46B94-32AA-49AA-A716-890A97C63C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025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3" Type="http://schemas.openxmlformats.org/officeDocument/2006/relationships/image" Target="../media/image1.png"/><Relationship Id="rId7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Google Shape;300;g9a84c083cf_0_56"/>
          <p:cNvSpPr/>
          <p:nvPr/>
        </p:nvSpPr>
        <p:spPr>
          <a:xfrm>
            <a:off x="313200" y="274451"/>
            <a:ext cx="428123" cy="6997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5269" tIns="42623" rIns="85269" bIns="42623" anchor="t" anchorCtr="0">
            <a:no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Google Shape;301;g9a84c083cf_0_56"/>
          <p:cNvSpPr/>
          <p:nvPr/>
        </p:nvSpPr>
        <p:spPr>
          <a:xfrm>
            <a:off x="733817" y="448740"/>
            <a:ext cx="2078747" cy="9613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5269" tIns="42623" rIns="85269" bIns="42623" anchor="t" anchorCtr="0">
            <a:no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OGD-VEH vs. CONTROL-VEH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b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b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b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Google Shape;302;g9a84c083cf_0_56"/>
          <p:cNvSpPr/>
          <p:nvPr/>
        </p:nvSpPr>
        <p:spPr>
          <a:xfrm>
            <a:off x="3703040" y="449894"/>
            <a:ext cx="1907321" cy="9613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5269" tIns="42623" rIns="85269" bIns="42623" anchor="t" anchorCtr="0">
            <a:no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OGD-TIA vs. CONTROL-TIA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b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b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b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Google Shape;303;g9a84c083cf_0_56"/>
          <p:cNvSpPr/>
          <p:nvPr/>
        </p:nvSpPr>
        <p:spPr>
          <a:xfrm>
            <a:off x="679498" y="2596391"/>
            <a:ext cx="2301930" cy="9613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5269" tIns="42623" rIns="85269" bIns="42623" anchor="t" anchorCtr="0">
            <a:no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ONTROL-TIA vs. CONTROL-VEH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b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b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b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Google Shape;304;g9a84c083cf_0_56"/>
          <p:cNvSpPr/>
          <p:nvPr/>
        </p:nvSpPr>
        <p:spPr>
          <a:xfrm>
            <a:off x="3703038" y="2595271"/>
            <a:ext cx="1823525" cy="9613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5269" tIns="42623" rIns="85269" bIns="42623" anchor="t" anchorCtr="0">
            <a:no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OGD-TIA vs. OGD-VEH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b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b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b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Google Shape;305;g9a84c083cf_0_56"/>
          <p:cNvGrpSpPr/>
          <p:nvPr/>
        </p:nvGrpSpPr>
        <p:grpSpPr>
          <a:xfrm>
            <a:off x="684279" y="714743"/>
            <a:ext cx="2324611" cy="1926036"/>
            <a:chOff x="484339" y="1787346"/>
            <a:chExt cx="2808906" cy="2478918"/>
          </a:xfrm>
        </p:grpSpPr>
        <p:pic>
          <p:nvPicPr>
            <p:cNvPr id="10" name="Google Shape;306;g9a84c083cf_0_56"/>
            <p:cNvPicPr preferRelativeResize="0"/>
            <p:nvPr/>
          </p:nvPicPr>
          <p:blipFill rotWithShape="1">
            <a:blip r:embed="rId3">
              <a:alphaModFix/>
            </a:blip>
            <a:srcRect r="28591" b="28607"/>
            <a:stretch/>
          </p:blipFill>
          <p:spPr>
            <a:xfrm>
              <a:off x="484339" y="1787346"/>
              <a:ext cx="1859259" cy="164085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1" name="Google Shape;307;g9a84c083cf_0_56"/>
            <p:cNvSpPr txBox="1"/>
            <p:nvPr/>
          </p:nvSpPr>
          <p:spPr>
            <a:xfrm>
              <a:off x="2279245" y="2332477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CTRL-Veh (2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Google Shape;308;g9a84c083cf_0_56"/>
            <p:cNvSpPr txBox="1"/>
            <p:nvPr/>
          </p:nvSpPr>
          <p:spPr>
            <a:xfrm>
              <a:off x="2279245" y="2458676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CTRL-</a:t>
              </a:r>
              <a:r>
                <a:rPr lang="de-DE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r>
                <a:rPr lang="de-DE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(1)</a:t>
              </a:r>
              <a:endParaRPr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Google Shape;309;g9a84c083cf_0_56"/>
            <p:cNvSpPr txBox="1"/>
            <p:nvPr/>
          </p:nvSpPr>
          <p:spPr>
            <a:xfrm>
              <a:off x="2279245" y="2584910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CTRL-</a:t>
              </a:r>
              <a:r>
                <a:rPr lang="de-DE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r>
                <a:rPr lang="de-DE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(3)</a:t>
              </a:r>
              <a:endParaRPr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Google Shape;310;g9a84c083cf_0_56"/>
            <p:cNvSpPr txBox="1"/>
            <p:nvPr/>
          </p:nvSpPr>
          <p:spPr>
            <a:xfrm>
              <a:off x="2270270" y="2837347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CTRL-</a:t>
              </a:r>
              <a:r>
                <a:rPr lang="de-DE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r>
                <a:rPr lang="de-DE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(4)</a:t>
              </a:r>
              <a:endParaRPr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Google Shape;311;g9a84c083cf_0_56"/>
            <p:cNvSpPr txBox="1"/>
            <p:nvPr/>
          </p:nvSpPr>
          <p:spPr>
            <a:xfrm>
              <a:off x="2270270" y="2711143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OGD-</a:t>
              </a:r>
              <a:r>
                <a:rPr lang="de-DE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r>
                <a:rPr lang="de-DE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(9)</a:t>
              </a:r>
              <a:endParaRPr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Google Shape;312;g9a84c083cf_0_56"/>
            <p:cNvSpPr txBox="1"/>
            <p:nvPr/>
          </p:nvSpPr>
          <p:spPr>
            <a:xfrm>
              <a:off x="2270270" y="2963605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OGD-</a:t>
              </a:r>
              <a:r>
                <a:rPr lang="de-DE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r>
                <a:rPr lang="de-DE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(10)</a:t>
              </a:r>
              <a:endParaRPr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Google Shape;313;g9a84c083cf_0_56"/>
            <p:cNvSpPr txBox="1"/>
            <p:nvPr/>
          </p:nvSpPr>
          <p:spPr>
            <a:xfrm>
              <a:off x="2270270" y="3089861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Veh (11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Google Shape;314;g9a84c083cf_0_56"/>
            <p:cNvSpPr txBox="1"/>
            <p:nvPr/>
          </p:nvSpPr>
          <p:spPr>
            <a:xfrm>
              <a:off x="2270270" y="3193963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OGD-</a:t>
              </a:r>
              <a:r>
                <a:rPr lang="de-DE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r>
                <a:rPr lang="de-DE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(12)</a:t>
              </a:r>
              <a:endParaRPr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Google Shape;315;g9a84c083cf_0_56"/>
            <p:cNvSpPr txBox="1"/>
            <p:nvPr/>
          </p:nvSpPr>
          <p:spPr>
            <a:xfrm rot="-5397696">
              <a:off x="1753395" y="3749814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CTRL-Veh (2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Google Shape;316;g9a84c083cf_0_56"/>
            <p:cNvSpPr txBox="1"/>
            <p:nvPr/>
          </p:nvSpPr>
          <p:spPr>
            <a:xfrm rot="-5400000">
              <a:off x="1606296" y="3749808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CTRL-Veh (1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Google Shape;317;g9a84c083cf_0_56"/>
            <p:cNvSpPr txBox="1"/>
            <p:nvPr/>
          </p:nvSpPr>
          <p:spPr>
            <a:xfrm rot="-5400000">
              <a:off x="1458676" y="3749813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CTRL-Veh (3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Google Shape;318;g9a84c083cf_0_56"/>
            <p:cNvSpPr txBox="1"/>
            <p:nvPr/>
          </p:nvSpPr>
          <p:spPr>
            <a:xfrm rot="-5400000">
              <a:off x="1312081" y="3749813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Veh (9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Google Shape;319;g9a84c083cf_0_56"/>
            <p:cNvSpPr txBox="1"/>
            <p:nvPr/>
          </p:nvSpPr>
          <p:spPr>
            <a:xfrm rot="-5400000">
              <a:off x="1154711" y="3749813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CTRL-Veh (4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Google Shape;320;g9a84c083cf_0_56"/>
            <p:cNvSpPr txBox="1"/>
            <p:nvPr/>
          </p:nvSpPr>
          <p:spPr>
            <a:xfrm rot="-5400000">
              <a:off x="1016854" y="3749813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OGD-</a:t>
              </a:r>
              <a:r>
                <a:rPr lang="de-DE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r>
                <a:rPr lang="de-DE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(10)</a:t>
              </a:r>
              <a:endParaRPr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Google Shape;321;g9a84c083cf_0_56"/>
            <p:cNvSpPr txBox="1"/>
            <p:nvPr/>
          </p:nvSpPr>
          <p:spPr>
            <a:xfrm rot="-5400000">
              <a:off x="871688" y="3758909"/>
              <a:ext cx="892500" cy="1194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Veh (11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Google Shape;322;g9a84c083cf_0_56"/>
            <p:cNvSpPr txBox="1"/>
            <p:nvPr/>
          </p:nvSpPr>
          <p:spPr>
            <a:xfrm rot="-5400000">
              <a:off x="723665" y="3749813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Veh (12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" name="Google Shape;323;g9a84c083cf_0_56"/>
          <p:cNvGrpSpPr/>
          <p:nvPr/>
        </p:nvGrpSpPr>
        <p:grpSpPr>
          <a:xfrm>
            <a:off x="3497101" y="713699"/>
            <a:ext cx="2324658" cy="1925774"/>
            <a:chOff x="3477300" y="3796300"/>
            <a:chExt cx="2784695" cy="2436739"/>
          </a:xfrm>
        </p:grpSpPr>
        <p:sp>
          <p:nvSpPr>
            <p:cNvPr id="28" name="Google Shape;324;g9a84c083cf_0_56"/>
            <p:cNvSpPr txBox="1"/>
            <p:nvPr/>
          </p:nvSpPr>
          <p:spPr>
            <a:xfrm>
              <a:off x="5247995" y="4327952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CTRL-TIA (6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Google Shape;325;g9a84c083cf_0_56"/>
            <p:cNvSpPr txBox="1"/>
            <p:nvPr/>
          </p:nvSpPr>
          <p:spPr>
            <a:xfrm>
              <a:off x="5247995" y="4454151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TIA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7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Google Shape;326;g9a84c083cf_0_56"/>
            <p:cNvSpPr txBox="1"/>
            <p:nvPr/>
          </p:nvSpPr>
          <p:spPr>
            <a:xfrm>
              <a:off x="5247995" y="4580385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TIA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8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Google Shape;327;g9a84c083cf_0_56"/>
            <p:cNvSpPr txBox="1"/>
            <p:nvPr/>
          </p:nvSpPr>
          <p:spPr>
            <a:xfrm>
              <a:off x="5239020" y="4832822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TIA (14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Google Shape;328;g9a84c083cf_0_56"/>
            <p:cNvSpPr txBox="1"/>
            <p:nvPr/>
          </p:nvSpPr>
          <p:spPr>
            <a:xfrm>
              <a:off x="5239020" y="4706618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TIA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5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Google Shape;329;g9a84c083cf_0_56"/>
            <p:cNvSpPr txBox="1"/>
            <p:nvPr/>
          </p:nvSpPr>
          <p:spPr>
            <a:xfrm>
              <a:off x="5239020" y="4959080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TIA (15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Google Shape;330;g9a84c083cf_0_56"/>
            <p:cNvSpPr txBox="1"/>
            <p:nvPr/>
          </p:nvSpPr>
          <p:spPr>
            <a:xfrm>
              <a:off x="5239020" y="5085336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TIA (13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Google Shape;331;g9a84c083cf_0_56"/>
            <p:cNvSpPr txBox="1"/>
            <p:nvPr/>
          </p:nvSpPr>
          <p:spPr>
            <a:xfrm>
              <a:off x="5239020" y="5189438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TIA (16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Google Shape;332;g9a84c083cf_0_56"/>
            <p:cNvSpPr txBox="1"/>
            <p:nvPr/>
          </p:nvSpPr>
          <p:spPr>
            <a:xfrm rot="-5397696">
              <a:off x="4731245" y="5716589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TIA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6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Google Shape;333;g9a84c083cf_0_56"/>
            <p:cNvSpPr txBox="1"/>
            <p:nvPr/>
          </p:nvSpPr>
          <p:spPr>
            <a:xfrm rot="-5400000">
              <a:off x="4584146" y="5716583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TIA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7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Google Shape;334;g9a84c083cf_0_56"/>
            <p:cNvSpPr txBox="1"/>
            <p:nvPr/>
          </p:nvSpPr>
          <p:spPr>
            <a:xfrm rot="-5400000">
              <a:off x="4436526" y="5716588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TIA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8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Google Shape;335;g9a84c083cf_0_56"/>
            <p:cNvSpPr txBox="1"/>
            <p:nvPr/>
          </p:nvSpPr>
          <p:spPr>
            <a:xfrm rot="-5400000">
              <a:off x="4289931" y="5716588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TIA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5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Google Shape;336;g9a84c083cf_0_56"/>
            <p:cNvSpPr txBox="1"/>
            <p:nvPr/>
          </p:nvSpPr>
          <p:spPr>
            <a:xfrm rot="-5400000">
              <a:off x="4132561" y="5716588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TIA (14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Google Shape;337;g9a84c083cf_0_56"/>
            <p:cNvSpPr txBox="1"/>
            <p:nvPr/>
          </p:nvSpPr>
          <p:spPr>
            <a:xfrm rot="-5400000">
              <a:off x="3994704" y="5716588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TIA (15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Google Shape;338;g9a84c083cf_0_56"/>
            <p:cNvSpPr txBox="1"/>
            <p:nvPr/>
          </p:nvSpPr>
          <p:spPr>
            <a:xfrm rot="-5400000">
              <a:off x="3849538" y="5725684"/>
              <a:ext cx="892500" cy="1194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TIA (13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Google Shape;339;g9a84c083cf_0_56"/>
            <p:cNvSpPr txBox="1"/>
            <p:nvPr/>
          </p:nvSpPr>
          <p:spPr>
            <a:xfrm rot="-5400000">
              <a:off x="3701515" y="5716588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TIA (16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4" name="Google Shape;340;g9a84c083cf_0_56"/>
            <p:cNvPicPr preferRelativeResize="0"/>
            <p:nvPr/>
          </p:nvPicPr>
          <p:blipFill rotWithShape="1">
            <a:blip r:embed="rId4">
              <a:alphaModFix/>
            </a:blip>
            <a:srcRect r="28505" b="28494"/>
            <a:stretch/>
          </p:blipFill>
          <p:spPr>
            <a:xfrm>
              <a:off x="3477300" y="3796300"/>
              <a:ext cx="1853924" cy="1640850"/>
            </a:xfrm>
            <a:prstGeom prst="rect">
              <a:avLst/>
            </a:prstGeom>
            <a:noFill/>
            <a:ln>
              <a:noFill/>
            </a:ln>
          </p:spPr>
        </p:pic>
      </p:grpSp>
      <p:grpSp>
        <p:nvGrpSpPr>
          <p:cNvPr id="45" name="Google Shape;341;g9a84c083cf_0_56"/>
          <p:cNvGrpSpPr/>
          <p:nvPr/>
        </p:nvGrpSpPr>
        <p:grpSpPr>
          <a:xfrm>
            <a:off x="685647" y="2863192"/>
            <a:ext cx="2324658" cy="1925774"/>
            <a:chOff x="1125375" y="6005725"/>
            <a:chExt cx="2806108" cy="2493214"/>
          </a:xfrm>
        </p:grpSpPr>
        <p:sp>
          <p:nvSpPr>
            <p:cNvPr id="46" name="Google Shape;342;g9a84c083cf_0_56"/>
            <p:cNvSpPr txBox="1"/>
            <p:nvPr/>
          </p:nvSpPr>
          <p:spPr>
            <a:xfrm>
              <a:off x="2917483" y="6543802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TIA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6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Google Shape;343;g9a84c083cf_0_56"/>
            <p:cNvSpPr txBox="1"/>
            <p:nvPr/>
          </p:nvSpPr>
          <p:spPr>
            <a:xfrm>
              <a:off x="2917483" y="6670001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TIA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7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Google Shape;344;g9a84c083cf_0_56"/>
            <p:cNvSpPr txBox="1"/>
            <p:nvPr/>
          </p:nvSpPr>
          <p:spPr>
            <a:xfrm>
              <a:off x="2917483" y="6796235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Veh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2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Google Shape;345;g9a84c083cf_0_56"/>
            <p:cNvSpPr txBox="1"/>
            <p:nvPr/>
          </p:nvSpPr>
          <p:spPr>
            <a:xfrm>
              <a:off x="2908508" y="7048672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TIA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8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Google Shape;346;g9a84c083cf_0_56"/>
            <p:cNvSpPr txBox="1"/>
            <p:nvPr/>
          </p:nvSpPr>
          <p:spPr>
            <a:xfrm>
              <a:off x="2908508" y="6922468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Veh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3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Google Shape;347;g9a84c083cf_0_56"/>
            <p:cNvSpPr txBox="1"/>
            <p:nvPr/>
          </p:nvSpPr>
          <p:spPr>
            <a:xfrm>
              <a:off x="2908508" y="7174930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TIA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5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Google Shape;348;g9a84c083cf_0_56"/>
            <p:cNvSpPr txBox="1"/>
            <p:nvPr/>
          </p:nvSpPr>
          <p:spPr>
            <a:xfrm>
              <a:off x="2908508" y="7301186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Veh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1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Google Shape;349;g9a84c083cf_0_56"/>
            <p:cNvSpPr txBox="1"/>
            <p:nvPr/>
          </p:nvSpPr>
          <p:spPr>
            <a:xfrm>
              <a:off x="2908508" y="7427363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Veh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4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Google Shape;350;g9a84c083cf_0_56"/>
            <p:cNvSpPr txBox="1"/>
            <p:nvPr/>
          </p:nvSpPr>
          <p:spPr>
            <a:xfrm rot="-5397696">
              <a:off x="2392995" y="7982489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TIA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6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Google Shape;351;g9a84c083cf_0_56"/>
            <p:cNvSpPr txBox="1"/>
            <p:nvPr/>
          </p:nvSpPr>
          <p:spPr>
            <a:xfrm rot="-5400000">
              <a:off x="2245896" y="7982483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TIA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7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Google Shape;352;g9a84c083cf_0_56"/>
            <p:cNvSpPr txBox="1"/>
            <p:nvPr/>
          </p:nvSpPr>
          <p:spPr>
            <a:xfrm rot="-5400000">
              <a:off x="2098276" y="7982488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Veh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2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Google Shape;353;g9a84c083cf_0_56"/>
            <p:cNvSpPr txBox="1"/>
            <p:nvPr/>
          </p:nvSpPr>
          <p:spPr>
            <a:xfrm rot="-5400000">
              <a:off x="1951681" y="7982488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Veh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3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Google Shape;354;g9a84c083cf_0_56"/>
            <p:cNvSpPr txBox="1"/>
            <p:nvPr/>
          </p:nvSpPr>
          <p:spPr>
            <a:xfrm rot="-5400000">
              <a:off x="1794311" y="7982488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TIA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8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Google Shape;355;g9a84c083cf_0_56"/>
            <p:cNvSpPr txBox="1"/>
            <p:nvPr/>
          </p:nvSpPr>
          <p:spPr>
            <a:xfrm rot="-5400000">
              <a:off x="1656454" y="7982488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TIA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5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Google Shape;356;g9a84c083cf_0_56"/>
            <p:cNvSpPr txBox="1"/>
            <p:nvPr/>
          </p:nvSpPr>
          <p:spPr>
            <a:xfrm rot="-5400000">
              <a:off x="1511288" y="7991584"/>
              <a:ext cx="892500" cy="1194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Veh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1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Google Shape;357;g9a84c083cf_0_56"/>
            <p:cNvSpPr txBox="1"/>
            <p:nvPr/>
          </p:nvSpPr>
          <p:spPr>
            <a:xfrm rot="-5400000">
              <a:off x="1363265" y="7982488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-Veh </a:t>
              </a:r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(4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2" name="Google Shape;358;g9a84c083cf_0_56"/>
            <p:cNvPicPr preferRelativeResize="0"/>
            <p:nvPr/>
          </p:nvPicPr>
          <p:blipFill rotWithShape="1">
            <a:blip r:embed="rId5">
              <a:alphaModFix/>
            </a:blip>
            <a:srcRect r="28510" b="28464"/>
            <a:stretch/>
          </p:blipFill>
          <p:spPr>
            <a:xfrm>
              <a:off x="1125375" y="6005725"/>
              <a:ext cx="1859251" cy="1640850"/>
            </a:xfrm>
            <a:prstGeom prst="rect">
              <a:avLst/>
            </a:prstGeom>
            <a:noFill/>
            <a:ln>
              <a:noFill/>
            </a:ln>
          </p:spPr>
        </p:pic>
      </p:grpSp>
      <p:grpSp>
        <p:nvGrpSpPr>
          <p:cNvPr id="63" name="Google Shape;359;g9a84c083cf_0_56"/>
          <p:cNvGrpSpPr/>
          <p:nvPr/>
        </p:nvGrpSpPr>
        <p:grpSpPr>
          <a:xfrm>
            <a:off x="3499367" y="2862374"/>
            <a:ext cx="2324658" cy="1925774"/>
            <a:chOff x="1072000" y="3534200"/>
            <a:chExt cx="2779908" cy="2447864"/>
          </a:xfrm>
        </p:grpSpPr>
        <p:sp>
          <p:nvSpPr>
            <p:cNvPr id="64" name="Google Shape;360;g9a84c083cf_0_56"/>
            <p:cNvSpPr txBox="1"/>
            <p:nvPr/>
          </p:nvSpPr>
          <p:spPr>
            <a:xfrm>
              <a:off x="2837908" y="4076977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Veh (10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Google Shape;361;g9a84c083cf_0_56"/>
            <p:cNvSpPr txBox="1"/>
            <p:nvPr/>
          </p:nvSpPr>
          <p:spPr>
            <a:xfrm>
              <a:off x="2837908" y="4203176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Veh (11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Google Shape;362;g9a84c083cf_0_56"/>
            <p:cNvSpPr txBox="1"/>
            <p:nvPr/>
          </p:nvSpPr>
          <p:spPr>
            <a:xfrm>
              <a:off x="2837908" y="4329410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TIA (16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Google Shape;363;g9a84c083cf_0_56"/>
            <p:cNvSpPr txBox="1"/>
            <p:nvPr/>
          </p:nvSpPr>
          <p:spPr>
            <a:xfrm>
              <a:off x="2828933" y="4581847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TIA (13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Google Shape;364;g9a84c083cf_0_56"/>
            <p:cNvSpPr txBox="1"/>
            <p:nvPr/>
          </p:nvSpPr>
          <p:spPr>
            <a:xfrm>
              <a:off x="2828933" y="4455643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Veh (12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Google Shape;365;g9a84c083cf_0_56"/>
            <p:cNvSpPr txBox="1"/>
            <p:nvPr/>
          </p:nvSpPr>
          <p:spPr>
            <a:xfrm>
              <a:off x="2828933" y="4708105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Veh (9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Google Shape;366;g9a84c083cf_0_56"/>
            <p:cNvSpPr txBox="1"/>
            <p:nvPr/>
          </p:nvSpPr>
          <p:spPr>
            <a:xfrm>
              <a:off x="2828933" y="4834361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TIA (15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Google Shape;367;g9a84c083cf_0_56"/>
            <p:cNvSpPr txBox="1"/>
            <p:nvPr/>
          </p:nvSpPr>
          <p:spPr>
            <a:xfrm>
              <a:off x="2828933" y="4938463"/>
              <a:ext cx="1014000" cy="121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TIA (14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Google Shape;368;g9a84c083cf_0_56"/>
            <p:cNvSpPr txBox="1"/>
            <p:nvPr/>
          </p:nvSpPr>
          <p:spPr>
            <a:xfrm rot="-5397696">
              <a:off x="2321145" y="5465614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Veh (10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Google Shape;369;g9a84c083cf_0_56"/>
            <p:cNvSpPr txBox="1"/>
            <p:nvPr/>
          </p:nvSpPr>
          <p:spPr>
            <a:xfrm rot="-5400000">
              <a:off x="2174046" y="5465608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OGD-</a:t>
              </a:r>
              <a:r>
                <a:rPr lang="de-DE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r>
                <a:rPr lang="de-DE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(11)</a:t>
              </a:r>
              <a:endParaRPr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Google Shape;370;g9a84c083cf_0_56"/>
            <p:cNvSpPr txBox="1"/>
            <p:nvPr/>
          </p:nvSpPr>
          <p:spPr>
            <a:xfrm rot="-5400000">
              <a:off x="2026426" y="5465613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TIA (16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Google Shape;371;g9a84c083cf_0_56"/>
            <p:cNvSpPr txBox="1"/>
            <p:nvPr/>
          </p:nvSpPr>
          <p:spPr>
            <a:xfrm rot="-5400000">
              <a:off x="1879831" y="5465613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Veh (12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Google Shape;372;g9a84c083cf_0_56"/>
            <p:cNvSpPr txBox="1"/>
            <p:nvPr/>
          </p:nvSpPr>
          <p:spPr>
            <a:xfrm rot="-5400000">
              <a:off x="1722461" y="5465613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TIA (13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Google Shape;373;g9a84c083cf_0_56"/>
            <p:cNvSpPr txBox="1"/>
            <p:nvPr/>
          </p:nvSpPr>
          <p:spPr>
            <a:xfrm rot="-5400000">
              <a:off x="1584604" y="5465613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Veh  (9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Google Shape;374;g9a84c083cf_0_56"/>
            <p:cNvSpPr txBox="1"/>
            <p:nvPr/>
          </p:nvSpPr>
          <p:spPr>
            <a:xfrm rot="-5400000">
              <a:off x="1439438" y="5474709"/>
              <a:ext cx="892500" cy="1194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TIA (15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Google Shape;375;g9a84c083cf_0_56"/>
            <p:cNvSpPr txBox="1"/>
            <p:nvPr/>
          </p:nvSpPr>
          <p:spPr>
            <a:xfrm rot="-5400000">
              <a:off x="1291415" y="5465613"/>
              <a:ext cx="895200" cy="137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5269" tIns="85269" rIns="85269" bIns="85269" anchor="t" anchorCtr="0">
              <a:noAutofit/>
            </a:bodyPr>
            <a:lstStyle/>
            <a:p>
              <a:pPr algn="r"/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OGD-TIA (14)</a:t>
              </a:r>
              <a:endParaRPr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0" name="Google Shape;376;g9a84c083cf_0_56"/>
            <p:cNvPicPr preferRelativeResize="0"/>
            <p:nvPr/>
          </p:nvPicPr>
          <p:blipFill rotWithShape="1">
            <a:blip r:embed="rId6">
              <a:alphaModFix/>
            </a:blip>
            <a:srcRect r="28197" b="28346"/>
            <a:stretch/>
          </p:blipFill>
          <p:spPr>
            <a:xfrm>
              <a:off x="1072000" y="3534200"/>
              <a:ext cx="1853924" cy="1640850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84" name="Google Shape;380;g9a84c083cf_0_56"/>
          <p:cNvSpPr txBox="1"/>
          <p:nvPr/>
        </p:nvSpPr>
        <p:spPr>
          <a:xfrm>
            <a:off x="3173402" y="7060147"/>
            <a:ext cx="1344461" cy="360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3" tIns="84393" rIns="84393" bIns="84393" anchor="t" anchorCtr="0">
            <a:no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-log10(p-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value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Google Shape;381;g9a84c083cf_0_56"/>
          <p:cNvSpPr/>
          <p:nvPr/>
        </p:nvSpPr>
        <p:spPr>
          <a:xfrm>
            <a:off x="616016" y="4801609"/>
            <a:ext cx="427016" cy="68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3" tIns="42185" rIns="84393" bIns="42185" anchor="t" anchorCtr="0">
            <a:noAutofit/>
          </a:bodyPr>
          <a:lstStyle/>
          <a:p>
            <a:endParaRPr sz="1292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br>
              <a:rPr lang="de-DE" sz="1292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endParaRPr sz="1292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Google Shape;382;g9a84c083cf_0_56"/>
          <p:cNvSpPr txBox="1"/>
          <p:nvPr/>
        </p:nvSpPr>
        <p:spPr>
          <a:xfrm>
            <a:off x="3173401" y="9373198"/>
            <a:ext cx="1344461" cy="360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3" tIns="84393" rIns="84393" bIns="84393" anchor="t" anchorCtr="0">
            <a:no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-log10(p-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value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Google Shape;383;g9a84c083cf_0_56"/>
          <p:cNvSpPr/>
          <p:nvPr/>
        </p:nvSpPr>
        <p:spPr>
          <a:xfrm>
            <a:off x="313200" y="4823110"/>
            <a:ext cx="427016" cy="68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3" tIns="42185" rIns="84393" bIns="42185" anchor="t" anchorCtr="0">
            <a:no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sz="1400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br>
              <a:rPr lang="de-DE" sz="14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endParaRPr sz="1400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Google Shape;384;g9a84c083cf_0_56"/>
          <p:cNvSpPr/>
          <p:nvPr/>
        </p:nvSpPr>
        <p:spPr>
          <a:xfrm>
            <a:off x="314307" y="7062031"/>
            <a:ext cx="427016" cy="68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3" tIns="42185" rIns="84393" bIns="42185" anchor="t" anchorCtr="0">
            <a:no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400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br>
              <a:rPr lang="de-DE" sz="14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endParaRPr sz="1400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9" name="Chart 8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77213326"/>
              </p:ext>
            </p:extLst>
          </p:nvPr>
        </p:nvGraphicFramePr>
        <p:xfrm>
          <a:off x="701547" y="5041024"/>
          <a:ext cx="4298400" cy="2084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90" name="Chart 8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32516571"/>
              </p:ext>
            </p:extLst>
          </p:nvPr>
        </p:nvGraphicFramePr>
        <p:xfrm>
          <a:off x="701546" y="7384656"/>
          <a:ext cx="4298401" cy="20828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</p:spTree>
    <p:extLst>
      <p:ext uri="{BB962C8B-B14F-4D97-AF65-F5344CB8AC3E}">
        <p14:creationId xmlns:p14="http://schemas.microsoft.com/office/powerpoint/2010/main" val="31863878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5165F878284174A9DAF41EBDC0CBE38" ma:contentTypeVersion="2" ma:contentTypeDescription="Create a new document." ma:contentTypeScope="" ma:versionID="1446cd1cca9ede4fdbb9d37d602b2df2">
  <xsd:schema xmlns:xsd="http://www.w3.org/2001/XMLSchema" xmlns:xs="http://www.w3.org/2001/XMLSchema" xmlns:p="http://schemas.microsoft.com/office/2006/metadata/properties" xmlns:ns2="c81dfc03-3b2f-4c41-8a9e-27c996741e2b" targetNamespace="http://schemas.microsoft.com/office/2006/metadata/properties" ma:root="true" ma:fieldsID="d9152f2d55eaecba5bad4de7b1335980" ns2:_="">
    <xsd:import namespace="c81dfc03-3b2f-4c41-8a9e-27c996741e2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81dfc03-3b2f-4c41-8a9e-27c996741e2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C1A4A06D-A8B2-40F1-8EC9-C166168458E3}"/>
</file>

<file path=customXml/itemProps2.xml><?xml version="1.0" encoding="utf-8"?>
<ds:datastoreItem xmlns:ds="http://schemas.openxmlformats.org/officeDocument/2006/customXml" ds:itemID="{E63D18FB-420B-4C34-B60B-783A1ABD9E0A}"/>
</file>

<file path=customXml/itemProps3.xml><?xml version="1.0" encoding="utf-8"?>
<ds:datastoreItem xmlns:ds="http://schemas.openxmlformats.org/officeDocument/2006/customXml" ds:itemID="{FCA6E634-C9D5-42DA-B882-490D623ABBB8}"/>
</file>

<file path=docProps/app.xml><?xml version="1.0" encoding="utf-8"?>
<Properties xmlns="http://schemas.openxmlformats.org/officeDocument/2006/extended-properties" xmlns:vt="http://schemas.openxmlformats.org/officeDocument/2006/docPropsVTypes">
  <TotalTime>98</TotalTime>
  <Words>342</Words>
  <Application>Microsoft Macintosh PowerPoint</Application>
  <PresentationFormat>A4 Paper (210x297 mm)</PresentationFormat>
  <Paragraphs>12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harité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soy, Burcu</dc:creator>
  <cp:lastModifiedBy>Microsoft Office User</cp:lastModifiedBy>
  <cp:revision>9</cp:revision>
  <cp:lastPrinted>2020-11-23T15:05:27Z</cp:lastPrinted>
  <dcterms:created xsi:type="dcterms:W3CDTF">2020-11-23T14:26:19Z</dcterms:created>
  <dcterms:modified xsi:type="dcterms:W3CDTF">2022-10-11T13:36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5165F878284174A9DAF41EBDC0CBE38</vt:lpwstr>
  </property>
</Properties>
</file>